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82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CE88B0F0-FB5B-4D8C-B4CE-6063086BD3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1456657"/>
              </p:ext>
            </p:extLst>
          </p:nvPr>
        </p:nvGraphicFramePr>
        <p:xfrm>
          <a:off x="724436" y="1020201"/>
          <a:ext cx="5216186" cy="2746625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7724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79912">
                  <a:extLst>
                    <a:ext uri="{9D8B030D-6E8A-4147-A177-3AD203B41FA5}">
                      <a16:colId xmlns:a16="http://schemas.microsoft.com/office/drawing/2014/main" val="739122903"/>
                    </a:ext>
                  </a:extLst>
                </a:gridCol>
                <a:gridCol w="1079912">
                  <a:extLst>
                    <a:ext uri="{9D8B030D-6E8A-4147-A177-3AD203B41FA5}">
                      <a16:colId xmlns:a16="http://schemas.microsoft.com/office/drawing/2014/main" val="3748112315"/>
                    </a:ext>
                  </a:extLst>
                </a:gridCol>
                <a:gridCol w="128393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3293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Total nb of 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genes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 of SSP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200" b="0" i="0" u="none" strike="noStrike" kern="1200" cap="none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percen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5976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,67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86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6.81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5976">
                <a:tc>
                  <a:txBody>
                    <a:bodyPr/>
                    <a:lstStyle/>
                    <a:p>
                      <a:pPr marL="0" marR="0" lvl="0" indent="0" algn="l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DEGs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,23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 % *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5976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 dpi up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e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3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7.98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3293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 dpi down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57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5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9.68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3293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5-9 dpi up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e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1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41 % **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4380728"/>
                  </a:ext>
                </a:extLst>
              </a:tr>
              <a:tr h="293293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5-9 dpi down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e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1102661"/>
                  </a:ext>
                </a:extLst>
              </a:tr>
              <a:tr h="293293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-15 dpi up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e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4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5.21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5763834"/>
                  </a:ext>
                </a:extLst>
              </a:tr>
              <a:tr h="293293">
                <a:tc>
                  <a:txBody>
                    <a:bodyPr/>
                    <a:lstStyle/>
                    <a:p>
                      <a:pPr marL="0" marR="0" lvl="0" indent="0" algn="r" rtl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2-15 dpi down-</a:t>
                      </a:r>
                      <a:r>
                        <a:rPr lang="fr-FR" sz="1200" b="0" i="0" u="none" strike="noStrike" kern="1200" cap="none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rgulated</a:t>
                      </a:r>
                      <a:endParaRPr lang="fr-FR" sz="1200" b="0" i="0" u="none" strike="noStrike" kern="1200" cap="none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Noto Sans CJK SC Regular" pitchFamily="2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4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i="0" u="none" strike="noStrike" kern="1200" cap="none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Noto Sans CJK SC Regular" pitchFamily="2"/>
                          <a:cs typeface="Times New Roman" panose="02020603050405020304" pitchFamily="18" charset="0"/>
                        </a:rPr>
                        <a:t>11.25 %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6777435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139CE89F-6DE6-6FD0-7865-5F9FAD255FB4}"/>
              </a:ext>
            </a:extLst>
          </p:cNvPr>
          <p:cNvSpPr txBox="1"/>
          <p:nvPr/>
        </p:nvSpPr>
        <p:spPr>
          <a:xfrm>
            <a:off x="724436" y="305832"/>
            <a:ext cx="5216186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8, Table S4. Enrichment analyses of the proportion of genes encoding Small Secreted Proteins (SSP) in the Differentially expressed gene (DEG) sets detected in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during cotyledon infection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DF80B72E-DA3C-8A1F-A74E-F89E19E55B5C}"/>
              </a:ext>
            </a:extLst>
          </p:cNvPr>
          <p:cNvSpPr txBox="1"/>
          <p:nvPr/>
        </p:nvSpPr>
        <p:spPr>
          <a:xfrm>
            <a:off x="724436" y="3881031"/>
            <a:ext cx="5216186" cy="13798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detect if genes encoding SSPs were over-represented in DEGs their proportion was compared to those of SSPs in the entire gene set of Lbb by a Chi-Squared test (** : p-value &lt; 0.001)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detect if a specific enrichment of genes encoding SSPs was found in each group of DEGs (2 dpi; 5-9 dpi; 12-15 dpi), their proportion was compared to the proportion of SSPs in the total DEGs set by a Chi-Squared test (** : p-value &lt; 0.001, *: p-value &lt; 0.05)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661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</TotalTime>
  <Words>197</Words>
  <Application>Microsoft Office PowerPoint</Application>
  <PresentationFormat>A4 Paper (210x297 mm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92</cp:revision>
  <dcterms:created xsi:type="dcterms:W3CDTF">2020-02-06T09:05:41Z</dcterms:created>
  <dcterms:modified xsi:type="dcterms:W3CDTF">2023-10-05T10:47:12Z</dcterms:modified>
</cp:coreProperties>
</file>